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12192000" cy="16256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43" d="100"/>
          <a:sy n="43" d="100"/>
        </p:scale>
        <p:origin x="3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8893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2966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7970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5944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7514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9401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151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5263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9946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4541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34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1A0BC-37FA-4275-A407-3AE66A0E5A32}" type="datetimeFigureOut">
              <a:rPr lang="es-ES" smtClean="0"/>
              <a:t>27/0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4DF06-0899-49B5-ADDE-53959209CD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7920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3660270" y="5380349"/>
            <a:ext cx="2281199" cy="1997829"/>
            <a:chOff x="2663827" y="4019733"/>
            <a:chExt cx="2281199" cy="1997829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2"/>
            <a:srcRect t="11215" r="46746"/>
            <a:stretch/>
          </p:blipFill>
          <p:spPr>
            <a:xfrm>
              <a:off x="2663827" y="4019733"/>
              <a:ext cx="2212974" cy="1925018"/>
            </a:xfrm>
            <a:prstGeom prst="rect">
              <a:avLst/>
            </a:prstGeom>
          </p:spPr>
        </p:pic>
        <p:sp>
          <p:nvSpPr>
            <p:cNvPr id="4" name="36 CuadroTexto"/>
            <p:cNvSpPr txBox="1"/>
            <p:nvPr/>
          </p:nvSpPr>
          <p:spPr>
            <a:xfrm>
              <a:off x="3711108" y="5617452"/>
              <a:ext cx="559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37 CuadroTexto"/>
            <p:cNvSpPr txBox="1"/>
            <p:nvPr/>
          </p:nvSpPr>
          <p:spPr>
            <a:xfrm>
              <a:off x="4147645" y="5617452"/>
              <a:ext cx="79738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AC1R </a:t>
              </a:r>
              <a:endParaRPr lang="es-E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6 h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36 CuadroTexto"/>
            <p:cNvSpPr txBox="1"/>
            <p:nvPr/>
          </p:nvSpPr>
          <p:spPr>
            <a:xfrm>
              <a:off x="3109465" y="5617452"/>
              <a:ext cx="645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upo 6"/>
          <p:cNvGrpSpPr/>
          <p:nvPr/>
        </p:nvGrpSpPr>
        <p:grpSpPr>
          <a:xfrm>
            <a:off x="5141321" y="3326730"/>
            <a:ext cx="2228951" cy="1854196"/>
            <a:chOff x="168175" y="4746100"/>
            <a:chExt cx="2228951" cy="1854196"/>
          </a:xfrm>
        </p:grpSpPr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3"/>
            <a:srcRect l="12526" t="15532" r="18751" b="67457"/>
            <a:stretch/>
          </p:blipFill>
          <p:spPr>
            <a:xfrm>
              <a:off x="231286" y="5073803"/>
              <a:ext cx="2165840" cy="299122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4"/>
            <a:srcRect l="11095" t="33217" r="16183" b="56344"/>
            <a:stretch/>
          </p:blipFill>
          <p:spPr>
            <a:xfrm>
              <a:off x="231285" y="4746100"/>
              <a:ext cx="2156316" cy="255350"/>
            </a:xfrm>
            <a:prstGeom prst="rect">
              <a:avLst/>
            </a:prstGeom>
          </p:spPr>
        </p:pic>
        <p:sp>
          <p:nvSpPr>
            <p:cNvPr id="12" name="35 CuadroTexto"/>
            <p:cNvSpPr txBox="1"/>
            <p:nvPr/>
          </p:nvSpPr>
          <p:spPr>
            <a:xfrm rot="18395975">
              <a:off x="-130110" y="5528180"/>
              <a:ext cx="842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1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36 CuadroTexto"/>
            <p:cNvSpPr txBox="1"/>
            <p:nvPr/>
          </p:nvSpPr>
          <p:spPr>
            <a:xfrm rot="18258822">
              <a:off x="628599" y="5496905"/>
              <a:ext cx="719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37 CuadroTexto"/>
            <p:cNvSpPr txBox="1"/>
            <p:nvPr/>
          </p:nvSpPr>
          <p:spPr>
            <a:xfrm rot="18070559">
              <a:off x="852486" y="5779074"/>
              <a:ext cx="1396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AC1R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 h 1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36 CuadroTexto"/>
            <p:cNvSpPr txBox="1"/>
            <p:nvPr/>
          </p:nvSpPr>
          <p:spPr>
            <a:xfrm rot="18258822">
              <a:off x="1011065" y="5496557"/>
              <a:ext cx="719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37 CuadroTexto"/>
            <p:cNvSpPr txBox="1"/>
            <p:nvPr/>
          </p:nvSpPr>
          <p:spPr>
            <a:xfrm rot="18070559">
              <a:off x="1221272" y="5779074"/>
              <a:ext cx="1396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AC1R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 h 2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35 CuadroTexto"/>
            <p:cNvSpPr txBox="1"/>
            <p:nvPr/>
          </p:nvSpPr>
          <p:spPr>
            <a:xfrm rot="18395975">
              <a:off x="196847" y="5528181"/>
              <a:ext cx="842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2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Grupo 17"/>
          <p:cNvGrpSpPr/>
          <p:nvPr/>
        </p:nvGrpSpPr>
        <p:grpSpPr>
          <a:xfrm>
            <a:off x="6906680" y="5380348"/>
            <a:ext cx="2405224" cy="2118303"/>
            <a:chOff x="4872527" y="4061589"/>
            <a:chExt cx="2405224" cy="2118303"/>
          </a:xfrm>
        </p:grpSpPr>
        <p:pic>
          <p:nvPicPr>
            <p:cNvPr id="19" name="Imagen 18"/>
            <p:cNvPicPr>
              <a:picLocks noChangeAspect="1"/>
            </p:cNvPicPr>
            <p:nvPr/>
          </p:nvPicPr>
          <p:blipFill rotWithShape="1">
            <a:blip r:embed="rId5"/>
            <a:srcRect t="14086" r="45717"/>
            <a:stretch/>
          </p:blipFill>
          <p:spPr>
            <a:xfrm>
              <a:off x="4872527" y="4061589"/>
              <a:ext cx="2405224" cy="2118303"/>
            </a:xfrm>
            <a:prstGeom prst="rect">
              <a:avLst/>
            </a:prstGeom>
          </p:spPr>
        </p:pic>
        <p:sp>
          <p:nvSpPr>
            <p:cNvPr id="20" name="36 CuadroTexto"/>
            <p:cNvSpPr txBox="1"/>
            <p:nvPr/>
          </p:nvSpPr>
          <p:spPr>
            <a:xfrm>
              <a:off x="6022772" y="5663618"/>
              <a:ext cx="559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37 CuadroTexto"/>
            <p:cNvSpPr txBox="1"/>
            <p:nvPr/>
          </p:nvSpPr>
          <p:spPr>
            <a:xfrm>
              <a:off x="6459309" y="5663618"/>
              <a:ext cx="79738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AC1R </a:t>
              </a:r>
              <a:endParaRPr lang="es-E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6 h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36 CuadroTexto"/>
            <p:cNvSpPr txBox="1"/>
            <p:nvPr/>
          </p:nvSpPr>
          <p:spPr>
            <a:xfrm>
              <a:off x="5421129" y="5663618"/>
              <a:ext cx="645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CuadroTexto 25"/>
          <p:cNvSpPr txBox="1"/>
          <p:nvPr/>
        </p:nvSpPr>
        <p:spPr>
          <a:xfrm>
            <a:off x="2574869" y="158183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uadroTexto 27"/>
          <p:cNvSpPr txBox="1"/>
          <p:nvPr/>
        </p:nvSpPr>
        <p:spPr>
          <a:xfrm>
            <a:off x="3598673" y="672050"/>
            <a:ext cx="49584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              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    Sham                                            TAC1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uadroTexto 28"/>
          <p:cNvSpPr txBox="1"/>
          <p:nvPr/>
        </p:nvSpPr>
        <p:spPr>
          <a:xfrm>
            <a:off x="4808901" y="288170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30" name="CuadroTexto 29"/>
          <p:cNvSpPr txBox="1"/>
          <p:nvPr/>
        </p:nvSpPr>
        <p:spPr>
          <a:xfrm>
            <a:off x="3587806" y="514383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31" name="CuadroTexto 30"/>
          <p:cNvSpPr txBox="1"/>
          <p:nvPr/>
        </p:nvSpPr>
        <p:spPr>
          <a:xfrm>
            <a:off x="6733658" y="514536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pic>
        <p:nvPicPr>
          <p:cNvPr id="33" name="Imagen 3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8180" y="938695"/>
            <a:ext cx="1993020" cy="1543068"/>
          </a:xfrm>
          <a:prstGeom prst="rect">
            <a:avLst/>
          </a:prstGeom>
        </p:spPr>
      </p:pic>
      <p:pic>
        <p:nvPicPr>
          <p:cNvPr id="34" name="Imagen 3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5712" y="933231"/>
            <a:ext cx="2057899" cy="1543424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1224" y="931707"/>
            <a:ext cx="1941597" cy="1559778"/>
          </a:xfrm>
          <a:prstGeom prst="rect">
            <a:avLst/>
          </a:prstGeom>
        </p:spPr>
      </p:pic>
      <p:cxnSp>
        <p:nvCxnSpPr>
          <p:cNvPr id="36" name="Conector recto 35"/>
          <p:cNvCxnSpPr/>
          <p:nvPr/>
        </p:nvCxnSpPr>
        <p:spPr>
          <a:xfrm>
            <a:off x="8782171" y="2347523"/>
            <a:ext cx="25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/>
          <p:cNvCxnSpPr/>
          <p:nvPr/>
        </p:nvCxnSpPr>
        <p:spPr>
          <a:xfrm>
            <a:off x="4652479" y="2347523"/>
            <a:ext cx="25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37"/>
          <p:cNvCxnSpPr/>
          <p:nvPr/>
        </p:nvCxnSpPr>
        <p:spPr>
          <a:xfrm>
            <a:off x="6681645" y="2347523"/>
            <a:ext cx="25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12">
            <a:extLst>
              <a:ext uri="{FF2B5EF4-FFF2-40B4-BE49-F238E27FC236}">
                <a16:creationId xmlns:a16="http://schemas.microsoft.com/office/drawing/2014/main" id="{1E43CA2E-0D2B-46D8-9061-F4BCE372233A}"/>
              </a:ext>
            </a:extLst>
          </p:cNvPr>
          <p:cNvSpPr/>
          <p:nvPr/>
        </p:nvSpPr>
        <p:spPr>
          <a:xfrm>
            <a:off x="4080797" y="3342330"/>
            <a:ext cx="116752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K1R (33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12">
            <a:extLst>
              <a:ext uri="{FF2B5EF4-FFF2-40B4-BE49-F238E27FC236}">
                <a16:creationId xmlns:a16="http://schemas.microsoft.com/office/drawing/2014/main" id="{1E43CA2E-0D2B-46D8-9061-F4BCE372233A}"/>
              </a:ext>
            </a:extLst>
          </p:cNvPr>
          <p:cNvSpPr/>
          <p:nvPr/>
        </p:nvSpPr>
        <p:spPr>
          <a:xfrm>
            <a:off x="4073423" y="3707334"/>
            <a:ext cx="116752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l-G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40 </a:t>
            </a:r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2909808" y="373255"/>
            <a:ext cx="267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ángulo 41"/>
          <p:cNvSpPr/>
          <p:nvPr/>
        </p:nvSpPr>
        <p:spPr>
          <a:xfrm>
            <a:off x="2825244" y="8416861"/>
            <a:ext cx="6096000" cy="58477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s-ES" sz="16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Figure 2</a:t>
            </a:r>
            <a:r>
              <a:rPr lang="es-E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s-ES" sz="16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61799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5</TotalTime>
  <Words>55</Words>
  <Application>Microsoft Office PowerPoint</Application>
  <PresentationFormat>Personalizado</PresentationFormat>
  <Paragraphs>2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NDRO ARGUELLES CASTILLA</dc:creator>
  <cp:lastModifiedBy>SANDRO ARGUELLES CASTILLA</cp:lastModifiedBy>
  <cp:revision>20</cp:revision>
  <dcterms:created xsi:type="dcterms:W3CDTF">2021-01-26T18:08:51Z</dcterms:created>
  <dcterms:modified xsi:type="dcterms:W3CDTF">2021-01-27T13:42:25Z</dcterms:modified>
</cp:coreProperties>
</file>